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0" d="100"/>
          <a:sy n="100" d="100"/>
        </p:scale>
        <p:origin x="85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F3916-7945-4D39-81D3-3B696747847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1AFA86-C868-44E7-A358-380209D4C035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50912" y="328613"/>
            <a:ext cx="6480301" cy="51435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995363" y="5944285"/>
            <a:ext cx="78390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S1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Principal component analysis (PCA) of the transcriptome across stages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1304926" y="6279827"/>
            <a:ext cx="70723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S2.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Hierarchical cluster tree displaying the co-expression modules</a:t>
            </a:r>
            <a:endParaRPr lang="zh-CN" altLang="en-US" dirty="0"/>
          </a:p>
        </p:txBody>
      </p:sp>
      <p:pic>
        <p:nvPicPr>
          <p:cNvPr id="2" name="图片 1" descr="FigS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67715" y="136525"/>
            <a:ext cx="7720330" cy="588962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347663" y="5518765"/>
            <a:ext cx="8539162" cy="1337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S3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qRT-PCR verified the expression of the core genes in the regulatory networks. R value in the top of each figure indicate Pearson correlation coefficient between relative expressions from qRT-PCR and transcriptome across stages.</a:t>
            </a:r>
            <a:endParaRPr lang="en-US" altLang="zh-CN" sz="1800" kern="100">
              <a:effectLst/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pic>
        <p:nvPicPr>
          <p:cNvPr id="3" name="图片 2" descr="FigS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4905" y="0"/>
            <a:ext cx="4314190" cy="563499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1</Words>
  <Application>WPS 演示</Application>
  <PresentationFormat>全屏显示(4:3)</PresentationFormat>
  <Paragraphs>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等线 Light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ui kang</dc:creator>
  <cp:lastModifiedBy>Administrator</cp:lastModifiedBy>
  <cp:revision>2</cp:revision>
  <dcterms:created xsi:type="dcterms:W3CDTF">2022-02-08T03:37:00Z</dcterms:created>
  <dcterms:modified xsi:type="dcterms:W3CDTF">2022-03-20T01:0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3C07D221D2F4F40BE2306A8683CD27A</vt:lpwstr>
  </property>
  <property fmtid="{D5CDD505-2E9C-101B-9397-08002B2CF9AE}" pid="3" name="KSOProductBuildVer">
    <vt:lpwstr>2052-11.1.0.11365</vt:lpwstr>
  </property>
</Properties>
</file>